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9" r:id="rId2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CDEF"/>
    <a:srgbClr val="FFCCCC"/>
    <a:srgbClr val="2C11F7"/>
    <a:srgbClr val="CCFFCC"/>
    <a:srgbClr val="CCCC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4" autoAdjust="0"/>
    <p:restoredTop sz="94660"/>
  </p:normalViewPr>
  <p:slideViewPr>
    <p:cSldViewPr snapToGrid="0">
      <p:cViewPr varScale="1">
        <p:scale>
          <a:sx n="77" d="100"/>
          <a:sy n="77" d="100"/>
        </p:scale>
        <p:origin x="24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28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75F1C848-E130-413A-A8DA-8172A53B0D88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C6F3B48-2B3A-4C55-BDFB-E1E416627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352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CB9EB20-C2EB-4A46-8805-2479D3AB5F2C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F07D6EC-DFDD-4EE7-ACA8-6578442E6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57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03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21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6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63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1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982" y="2707559"/>
            <a:ext cx="3904498" cy="2993973"/>
          </a:xfrm>
          <a:prstGeom prst="rect">
            <a:avLst/>
          </a:prstGeom>
        </p:spPr>
      </p:pic>
      <p:cxnSp>
        <p:nvCxnSpPr>
          <p:cNvPr id="28" name="Straight Arrow Connector 27"/>
          <p:cNvCxnSpPr/>
          <p:nvPr/>
        </p:nvCxnSpPr>
        <p:spPr>
          <a:xfrm>
            <a:off x="1555195" y="1463854"/>
            <a:ext cx="374560" cy="528501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>
            <a:off x="1692658" y="1383533"/>
            <a:ext cx="886298" cy="332439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419590" y="2531184"/>
            <a:ext cx="3156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>
            <a:off x="1721244" y="5259354"/>
            <a:ext cx="23196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2079457" y="5246999"/>
            <a:ext cx="49943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2739613" y="5238757"/>
            <a:ext cx="1177479" cy="8242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1715160" y="5274325"/>
            <a:ext cx="2848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989682" y="5274325"/>
            <a:ext cx="9995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file 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048373" y="5274325"/>
            <a:ext cx="9995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file 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/>
          <p:cNvCxnSpPr/>
          <p:nvPr/>
        </p:nvCxnSpPr>
        <p:spPr>
          <a:xfrm flipV="1">
            <a:off x="1506162" y="3823919"/>
            <a:ext cx="2743200" cy="3252"/>
          </a:xfrm>
          <a:prstGeom prst="line">
            <a:avLst/>
          </a:prstGeom>
          <a:ln w="12700">
            <a:solidFill>
              <a:schemeClr val="bg2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2116528" y="1096868"/>
            <a:ext cx="5573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7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179809" y="1263129"/>
            <a:ext cx="1374370" cy="87086"/>
            <a:chOff x="4837399" y="1136645"/>
            <a:chExt cx="1374370" cy="87086"/>
          </a:xfrm>
        </p:grpSpPr>
        <p:cxnSp>
          <p:nvCxnSpPr>
            <p:cNvPr id="6" name="Straight Connector 5"/>
            <p:cNvCxnSpPr/>
            <p:nvPr/>
          </p:nvCxnSpPr>
          <p:spPr>
            <a:xfrm>
              <a:off x="4837399" y="1179835"/>
              <a:ext cx="1374370" cy="0"/>
            </a:xfrm>
            <a:prstGeom prst="line">
              <a:avLst/>
            </a:prstGeom>
            <a:ln w="2857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Rectangle 6"/>
            <p:cNvSpPr/>
            <p:nvPr/>
          </p:nvSpPr>
          <p:spPr>
            <a:xfrm>
              <a:off x="5430879" y="1136645"/>
              <a:ext cx="45719" cy="87086"/>
            </a:xfrm>
            <a:prstGeom prst="rect">
              <a:avLst/>
            </a:prstGeom>
            <a:solidFill>
              <a:schemeClr val="accent4"/>
            </a:solidFill>
            <a:ln>
              <a:noFill/>
            </a:ln>
            <a:effectLst/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>
              <a:bevelT w="139700" h="1397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Oval 7"/>
            <p:cNvSpPr/>
            <p:nvPr/>
          </p:nvSpPr>
          <p:spPr>
            <a:xfrm>
              <a:off x="5134408" y="1136645"/>
              <a:ext cx="87088" cy="87086"/>
            </a:xfrm>
            <a:prstGeom prst="ellipse">
              <a:avLst/>
            </a:prstGeom>
            <a:solidFill>
              <a:srgbClr val="009900"/>
            </a:solidFill>
            <a:ln>
              <a:noFill/>
            </a:ln>
            <a:effectLst/>
            <a:scene3d>
              <a:camera prst="orthographicFront">
                <a:rot lat="0" lon="0" rev="0"/>
              </a:camera>
              <a:lightRig rig="contrasting" dir="t">
                <a:rot lat="0" lon="0" rev="1500000"/>
              </a:lightRig>
            </a:scene3d>
            <a:sp3d prstMaterial="metal">
              <a:bevelT w="88900" h="889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Oval 8"/>
          <p:cNvSpPr/>
          <p:nvPr/>
        </p:nvSpPr>
        <p:spPr>
          <a:xfrm>
            <a:off x="1403092" y="1261828"/>
            <a:ext cx="87088" cy="87086"/>
          </a:xfrm>
          <a:prstGeom prst="ellipse">
            <a:avLst/>
          </a:prstGeom>
          <a:solidFill>
            <a:srgbClr val="CC99FF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V="1">
            <a:off x="1076272" y="1424978"/>
            <a:ext cx="221748" cy="241928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932852" y="1383533"/>
            <a:ext cx="4664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Arrow Connector 11"/>
          <p:cNvCxnSpPr>
            <a:stCxn id="11" idx="3"/>
          </p:cNvCxnSpPr>
          <p:nvPr/>
        </p:nvCxnSpPr>
        <p:spPr>
          <a:xfrm flipH="1">
            <a:off x="1185593" y="1506644"/>
            <a:ext cx="213673" cy="347667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Arc 12"/>
          <p:cNvSpPr/>
          <p:nvPr/>
        </p:nvSpPr>
        <p:spPr>
          <a:xfrm>
            <a:off x="1434792" y="1179758"/>
            <a:ext cx="87386" cy="88505"/>
          </a:xfrm>
          <a:prstGeom prst="arc">
            <a:avLst>
              <a:gd name="adj1" fmla="val 9779208"/>
              <a:gd name="adj2" fmla="val 1127077"/>
            </a:avLst>
          </a:prstGeom>
          <a:ln w="12700">
            <a:solidFill>
              <a:schemeClr val="bg2">
                <a:lumMod val="50000"/>
              </a:schemeClr>
            </a:solidFill>
            <a:prstDash val="sysDash"/>
            <a:head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357878" y="1011693"/>
            <a:ext cx="4475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Arrow Connector 14"/>
          <p:cNvCxnSpPr>
            <a:endCxn id="19" idx="0"/>
          </p:cNvCxnSpPr>
          <p:nvPr/>
        </p:nvCxnSpPr>
        <p:spPr>
          <a:xfrm flipH="1">
            <a:off x="1386572" y="1520050"/>
            <a:ext cx="84640" cy="439453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572919" y="1654325"/>
            <a:ext cx="709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28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Tab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844700"/>
              </p:ext>
            </p:extLst>
          </p:nvPr>
        </p:nvGraphicFramePr>
        <p:xfrm>
          <a:off x="3386608" y="1041080"/>
          <a:ext cx="2386040" cy="40210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860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860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3860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3860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3860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3860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3860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3860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3860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3860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192607">
                <a:tc gridSpan="10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i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file 4 GFP</a:t>
                      </a:r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9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Met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18288" marB="18288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marT="18288" marB="18288" anchor="ctr">
                    <a:lnL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9502"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</a:t>
                      </a:r>
                      <a:endParaRPr kumimoji="0" lang="en-US" sz="9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8" name="TextBox 17"/>
          <p:cNvSpPr txBox="1"/>
          <p:nvPr/>
        </p:nvSpPr>
        <p:spPr>
          <a:xfrm>
            <a:off x="2130890" y="1900283"/>
            <a:ext cx="746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GNP1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107897" y="1959503"/>
            <a:ext cx="5573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6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083541" y="1531610"/>
            <a:ext cx="2359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223033" y="1625341"/>
            <a:ext cx="2391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1529222" y="1499722"/>
            <a:ext cx="101100" cy="616138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793461" y="1845064"/>
            <a:ext cx="7366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1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377660" y="1698576"/>
            <a:ext cx="2391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560106" y="1717659"/>
            <a:ext cx="2391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>
            <a:off x="1606968" y="1448933"/>
            <a:ext cx="621325" cy="516634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1610588" y="1953178"/>
            <a:ext cx="7393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YIL055C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378520" y="1790665"/>
            <a:ext cx="8734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YRR1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822850" y="1705929"/>
            <a:ext cx="2464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 rot="16200000">
            <a:off x="260913" y="3954038"/>
            <a:ext cx="1672269" cy="251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C fold change (Log</a:t>
            </a:r>
            <a:r>
              <a:rPr lang="en-US" sz="105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19590" y="981768"/>
            <a:ext cx="3156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41892" y="5763691"/>
            <a:ext cx="570766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teractions between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ET3pr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nd profile 1 Met4-targetd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tes and their quantitative changes upon methionine induction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teractions between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ET3p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lected profile 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t4-target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ites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C signal change of profile 4 and profile 1 sites (2-9 in A) befo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afte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duction. Signals are normalized by the positive control (P).The dash line represents the average 3C signal increase of profile 4 interactions. Overall, profile 1 sites have less changes in interaction strengths comparing with profile 4 sites (P value = </a:t>
            </a:r>
            <a:r>
              <a:rPr lang="en-US" sz="1200" dirty="0" smtClean="0"/>
              <a:t>0.0022)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Arrow Connector 47"/>
          <p:cNvCxnSpPr/>
          <p:nvPr/>
        </p:nvCxnSpPr>
        <p:spPr>
          <a:xfrm>
            <a:off x="1715160" y="1370561"/>
            <a:ext cx="863733" cy="140193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2522300" y="1430666"/>
            <a:ext cx="8734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PT1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2501964" y="1647931"/>
            <a:ext cx="8734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AM3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073606" y="1685454"/>
            <a:ext cx="2464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191071" y="1565378"/>
            <a:ext cx="2464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Straight Arrow Connector 65"/>
          <p:cNvCxnSpPr/>
          <p:nvPr/>
        </p:nvCxnSpPr>
        <p:spPr>
          <a:xfrm>
            <a:off x="1646618" y="1404223"/>
            <a:ext cx="831866" cy="434006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prstDash val="sysDash"/>
            <a:tailEnd type="non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2343521" y="1446045"/>
            <a:ext cx="2464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355828" y="2111355"/>
            <a:ext cx="5573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ET8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Group 32"/>
          <p:cNvGrpSpPr/>
          <p:nvPr/>
        </p:nvGrpSpPr>
        <p:grpSpPr>
          <a:xfrm>
            <a:off x="3118094" y="1478254"/>
            <a:ext cx="2686358" cy="877769"/>
            <a:chOff x="3487748" y="1464034"/>
            <a:chExt cx="2478786" cy="751309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77" t="45319" r="45375" b="37320"/>
            <a:stretch/>
          </p:blipFill>
          <p:spPr>
            <a:xfrm>
              <a:off x="3487748" y="1464034"/>
              <a:ext cx="1317407" cy="751309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258" t="41762" r="26199" b="42234"/>
            <a:stretch/>
          </p:blipFill>
          <p:spPr>
            <a:xfrm>
              <a:off x="4801451" y="1464035"/>
              <a:ext cx="1165083" cy="751308"/>
            </a:xfrm>
            <a:prstGeom prst="rect">
              <a:avLst/>
            </a:prstGeom>
          </p:spPr>
        </p:pic>
      </p:grpSp>
      <p:sp>
        <p:nvSpPr>
          <p:cNvPr id="42" name="Left Bracket 41"/>
          <p:cNvSpPr/>
          <p:nvPr/>
        </p:nvSpPr>
        <p:spPr>
          <a:xfrm rot="5400000">
            <a:off x="2263525" y="2763161"/>
            <a:ext cx="55739" cy="624424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Left Bracket 56"/>
          <p:cNvSpPr/>
          <p:nvPr/>
        </p:nvSpPr>
        <p:spPr>
          <a:xfrm rot="5400000">
            <a:off x="3309905" y="2848087"/>
            <a:ext cx="68577" cy="1145793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Left Bracket 57"/>
          <p:cNvSpPr/>
          <p:nvPr/>
        </p:nvSpPr>
        <p:spPr>
          <a:xfrm rot="5400000">
            <a:off x="2795760" y="2349864"/>
            <a:ext cx="55740" cy="1088782"/>
          </a:xfrm>
          <a:prstGeom prst="lef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9" name="Straight Connector 48"/>
          <p:cNvCxnSpPr/>
          <p:nvPr/>
        </p:nvCxnSpPr>
        <p:spPr>
          <a:xfrm>
            <a:off x="3371009" y="2928339"/>
            <a:ext cx="0" cy="3391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2705825" y="2684844"/>
            <a:ext cx="4656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5440496" y="297899"/>
            <a:ext cx="11107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u_Fig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6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89627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3</TotalTime>
  <Words>151</Words>
  <Application>Microsoft Office PowerPoint</Application>
  <PresentationFormat>Letter Paper (8.5x11 in)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u Du</dc:creator>
  <cp:lastModifiedBy>lucybai</cp:lastModifiedBy>
  <cp:revision>281</cp:revision>
  <cp:lastPrinted>2016-12-22T22:05:19Z</cp:lastPrinted>
  <dcterms:created xsi:type="dcterms:W3CDTF">2016-06-14T18:48:14Z</dcterms:created>
  <dcterms:modified xsi:type="dcterms:W3CDTF">2017-03-30T15:23:34Z</dcterms:modified>
</cp:coreProperties>
</file>